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9607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0467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5860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1305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3927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4148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897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9637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7038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032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3011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B99A1-E4DA-4DF1-9ADC-CF6699D70454}" type="datetimeFigureOut">
              <a:rPr lang="de-DE" smtClean="0"/>
              <a:t>28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6410D-B3D6-4E8F-8E0C-671ECDC268A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0355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2.png"/><Relationship Id="rId7" Type="http://schemas.openxmlformats.org/officeDocument/2006/relationships/image" Target="../media/image7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microsoft.com/office/2007/relationships/hdphoto" Target="../media/hdphoto2.wdp"/><Relationship Id="rId7" Type="http://schemas.openxmlformats.org/officeDocument/2006/relationships/image" Target="../media/image11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00" t="36154" r="38599" b="58026"/>
          <a:stretch/>
        </p:blipFill>
        <p:spPr>
          <a:xfrm>
            <a:off x="3797978" y="1939257"/>
            <a:ext cx="882000" cy="1348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122" t="36154" r="38477" b="57357"/>
          <a:stretch/>
        </p:blipFill>
        <p:spPr>
          <a:xfrm>
            <a:off x="3797978" y="2088670"/>
            <a:ext cx="882000" cy="1503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573" t="27500" r="37025" b="64643"/>
          <a:stretch/>
        </p:blipFill>
        <p:spPr>
          <a:xfrm>
            <a:off x="3797978" y="2260664"/>
            <a:ext cx="882000" cy="1819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25" t="34423" r="52356" b="60693"/>
          <a:stretch/>
        </p:blipFill>
        <p:spPr>
          <a:xfrm>
            <a:off x="3797128" y="2459858"/>
            <a:ext cx="379644" cy="1190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feld 8"/>
          <p:cNvSpPr txBox="1"/>
          <p:nvPr/>
        </p:nvSpPr>
        <p:spPr>
          <a:xfrm>
            <a:off x="4786979" y="1924432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Gerade Verbindung mit Pfeil 9"/>
          <p:cNvCxnSpPr/>
          <p:nvPr/>
        </p:nvCxnSpPr>
        <p:spPr>
          <a:xfrm flipH="1">
            <a:off x="4712273" y="201633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4789436" y="2043538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mit Pfeil 11"/>
          <p:cNvCxnSpPr/>
          <p:nvPr/>
        </p:nvCxnSpPr>
        <p:spPr>
          <a:xfrm flipH="1">
            <a:off x="4714730" y="213543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4786979" y="2249693"/>
            <a:ext cx="7724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 heavy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 Verbindung mit Pfeil 13"/>
          <p:cNvCxnSpPr/>
          <p:nvPr/>
        </p:nvCxnSpPr>
        <p:spPr>
          <a:xfrm flipH="1">
            <a:off x="4712273" y="234522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4786979" y="2449560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rade Verbindung mit Pfeil 15"/>
          <p:cNvCxnSpPr/>
          <p:nvPr/>
        </p:nvCxnSpPr>
        <p:spPr>
          <a:xfrm flipH="1">
            <a:off x="4712273" y="254509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>
            <a:off x="4612853" y="2101933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4608385" y="2329909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521824" y="2094164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3521824" y="2459858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3521824" y="2263441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521824" y="1940744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3626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00" t="36154" r="38599" b="58026"/>
          <a:stretch/>
        </p:blipFill>
        <p:spPr>
          <a:xfrm>
            <a:off x="793521" y="141194"/>
            <a:ext cx="882000" cy="1348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122" t="36154" r="38477" b="57357"/>
          <a:stretch/>
        </p:blipFill>
        <p:spPr>
          <a:xfrm>
            <a:off x="6594966" y="200848"/>
            <a:ext cx="882000" cy="1503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feld 5"/>
          <p:cNvSpPr txBox="1"/>
          <p:nvPr/>
        </p:nvSpPr>
        <p:spPr>
          <a:xfrm>
            <a:off x="1782522" y="126369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Gerade Verbindung mit Pfeil 6"/>
          <p:cNvCxnSpPr/>
          <p:nvPr/>
        </p:nvCxnSpPr>
        <p:spPr>
          <a:xfrm flipH="1">
            <a:off x="1707816" y="2182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/>
          <p:cNvSpPr txBox="1"/>
          <p:nvPr/>
        </p:nvSpPr>
        <p:spPr>
          <a:xfrm>
            <a:off x="7586424" y="155716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7511718" y="24761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feld 15"/>
          <p:cNvSpPr txBox="1"/>
          <p:nvPr/>
        </p:nvSpPr>
        <p:spPr>
          <a:xfrm>
            <a:off x="6318812" y="206342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17367" y="142681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035" b="29730"/>
          <a:stretch/>
        </p:blipFill>
        <p:spPr>
          <a:xfrm>
            <a:off x="200169" y="3903203"/>
            <a:ext cx="4348779" cy="2923583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59" t="9876" r="21621" b="30654"/>
          <a:stretch/>
        </p:blipFill>
        <p:spPr>
          <a:xfrm>
            <a:off x="5286806" y="691563"/>
            <a:ext cx="3158138" cy="2474259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897" b="30469"/>
          <a:stretch/>
        </p:blipFill>
        <p:spPr>
          <a:xfrm>
            <a:off x="4687644" y="3965153"/>
            <a:ext cx="4356463" cy="2892847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35" t="12094" r="22173" b="26405"/>
          <a:stretch/>
        </p:blipFill>
        <p:spPr>
          <a:xfrm>
            <a:off x="295815" y="402934"/>
            <a:ext cx="3112034" cy="2558783"/>
          </a:xfrm>
          <a:prstGeom prst="rect">
            <a:avLst/>
          </a:prstGeom>
        </p:spPr>
      </p:pic>
      <p:sp>
        <p:nvSpPr>
          <p:cNvPr id="24" name="Rechteck 23"/>
          <p:cNvSpPr/>
          <p:nvPr/>
        </p:nvSpPr>
        <p:spPr>
          <a:xfrm>
            <a:off x="5271124" y="405039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5263121" y="44615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5263121" y="45490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5263121" y="46403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263121" y="47410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263121" y="49646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263121" y="51770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263121" y="55412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263121" y="57250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263121" y="60425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263121" y="43399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5953606" y="426768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6" name="Rechteck 35"/>
          <p:cNvSpPr/>
          <p:nvPr/>
        </p:nvSpPr>
        <p:spPr>
          <a:xfrm>
            <a:off x="5895283" y="1811733"/>
            <a:ext cx="1616435" cy="262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7" name="Rechteck 36"/>
          <p:cNvSpPr/>
          <p:nvPr/>
        </p:nvSpPr>
        <p:spPr>
          <a:xfrm>
            <a:off x="5263121" y="63034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793521" y="400607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785518" y="44172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785518" y="45046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785518" y="45960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785518" y="46967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785518" y="49203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785518" y="51327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785518" y="54969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785518" y="56807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785518" y="59982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785518" y="42956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1476003" y="422337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0" name="Rechteck 49"/>
          <p:cNvSpPr/>
          <p:nvPr/>
        </p:nvSpPr>
        <p:spPr>
          <a:xfrm>
            <a:off x="898779" y="1438593"/>
            <a:ext cx="1644636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1" name="Rechteck 50"/>
          <p:cNvSpPr/>
          <p:nvPr/>
        </p:nvSpPr>
        <p:spPr>
          <a:xfrm>
            <a:off x="785518" y="62591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71233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573" t="27500" r="37025" b="64643"/>
          <a:stretch/>
        </p:blipFill>
        <p:spPr>
          <a:xfrm>
            <a:off x="639841" y="278183"/>
            <a:ext cx="882000" cy="1819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25" t="34423" r="52356" b="60693"/>
          <a:stretch/>
        </p:blipFill>
        <p:spPr>
          <a:xfrm>
            <a:off x="6770849" y="288481"/>
            <a:ext cx="379644" cy="1190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feld 3"/>
          <p:cNvSpPr txBox="1"/>
          <p:nvPr/>
        </p:nvSpPr>
        <p:spPr>
          <a:xfrm>
            <a:off x="1628842" y="267212"/>
            <a:ext cx="7724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 heavy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1554136" y="3627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7760700" y="278183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Gerade Verbindung mit Pfeil 6"/>
          <p:cNvCxnSpPr/>
          <p:nvPr/>
        </p:nvCxnSpPr>
        <p:spPr>
          <a:xfrm flipH="1">
            <a:off x="7685994" y="37371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6495545" y="288481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63687" y="280960"/>
            <a:ext cx="3372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78" t="2119" r="18729" b="21974"/>
          <a:stretch/>
        </p:blipFill>
        <p:spPr>
          <a:xfrm>
            <a:off x="4731628" y="3465499"/>
            <a:ext cx="3865069" cy="3158138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7" t="15248" r="21484" b="24543"/>
          <a:stretch/>
        </p:blipFill>
        <p:spPr>
          <a:xfrm>
            <a:off x="5286725" y="503031"/>
            <a:ext cx="2850776" cy="2504995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99" t="8953" r="20244" b="24928"/>
          <a:stretch/>
        </p:blipFill>
        <p:spPr>
          <a:xfrm>
            <a:off x="639841" y="555718"/>
            <a:ext cx="3165822" cy="2750884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519" b="25667"/>
          <a:stretch/>
        </p:blipFill>
        <p:spPr>
          <a:xfrm>
            <a:off x="184664" y="3607846"/>
            <a:ext cx="4433303" cy="3092631"/>
          </a:xfrm>
          <a:prstGeom prst="rect">
            <a:avLst/>
          </a:prstGeom>
        </p:spPr>
      </p:pic>
      <p:sp>
        <p:nvSpPr>
          <p:cNvPr id="17" name="Rechteck 16"/>
          <p:cNvSpPr/>
          <p:nvPr/>
        </p:nvSpPr>
        <p:spPr>
          <a:xfrm>
            <a:off x="4798679" y="377376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4790676" y="41849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790676" y="42723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4790676" y="43637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4790676" y="44644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4790676" y="46879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790676" y="49003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4790676" y="52646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4790676" y="54484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4790676" y="57659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790676" y="40633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5481161" y="399106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9" name="Rechteck 28"/>
          <p:cNvSpPr/>
          <p:nvPr/>
        </p:nvSpPr>
        <p:spPr>
          <a:xfrm>
            <a:off x="5744685" y="1301230"/>
            <a:ext cx="671483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hteck 29"/>
          <p:cNvSpPr/>
          <p:nvPr/>
        </p:nvSpPr>
        <p:spPr>
          <a:xfrm>
            <a:off x="4790676" y="60268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826168" y="386025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</a:t>
            </a:r>
            <a:r>
              <a:rPr lang="en-US" sz="1100" b="1" dirty="0" smtClean="0">
                <a:solidFill>
                  <a:schemeClr val="bg1"/>
                </a:solidFill>
              </a:rPr>
              <a:t>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</a:t>
            </a:r>
            <a:r>
              <a:rPr lang="en-US" sz="1100" b="1" dirty="0" smtClean="0">
                <a:solidFill>
                  <a:schemeClr val="bg1"/>
                </a:solidFill>
              </a:rPr>
              <a:t>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818165" y="42714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818165" y="43588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818165" y="44502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818165" y="45508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818165" y="47744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818165" y="49868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818165" y="53511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818165" y="55349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818165" y="58524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818165" y="41498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1508650" y="407755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3" name="Rechteck 42"/>
          <p:cNvSpPr/>
          <p:nvPr/>
        </p:nvSpPr>
        <p:spPr>
          <a:xfrm>
            <a:off x="1247127" y="1379717"/>
            <a:ext cx="1634386" cy="233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4" name="Rechteck 43"/>
          <p:cNvSpPr/>
          <p:nvPr/>
        </p:nvSpPr>
        <p:spPr>
          <a:xfrm>
            <a:off x="818165" y="61133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4337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</Words>
  <Application>Microsoft Office PowerPoint</Application>
  <PresentationFormat>Bildschirmpräsentation (4:3)</PresentationFormat>
  <Paragraphs>70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08-28T13:25:52Z</dcterms:created>
  <dcterms:modified xsi:type="dcterms:W3CDTF">2024-08-28T13:36:34Z</dcterms:modified>
</cp:coreProperties>
</file>